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  <p:sldId id="268" r:id="rId5"/>
    <p:sldId id="267" r:id="rId6"/>
    <p:sldId id="269" r:id="rId7"/>
    <p:sldId id="270" r:id="rId8"/>
    <p:sldId id="271" r:id="rId9"/>
    <p:sldId id="292" r:id="rId10"/>
    <p:sldId id="272" r:id="rId11"/>
    <p:sldId id="273" r:id="rId12"/>
    <p:sldId id="274" r:id="rId13"/>
    <p:sldId id="275" r:id="rId14"/>
    <p:sldId id="277" r:id="rId15"/>
    <p:sldId id="276" r:id="rId16"/>
    <p:sldId id="278" r:id="rId17"/>
    <p:sldId id="279" r:id="rId18"/>
    <p:sldId id="280" r:id="rId19"/>
    <p:sldId id="282" r:id="rId20"/>
    <p:sldId id="281" r:id="rId21"/>
    <p:sldId id="283" r:id="rId22"/>
    <p:sldId id="284" r:id="rId23"/>
    <p:sldId id="285" r:id="rId24"/>
    <p:sldId id="291" r:id="rId25"/>
    <p:sldId id="290" r:id="rId2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4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55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790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043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84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588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689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016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218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514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231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380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5EF03-069C-4780-A154-480786A7082F}" type="datetimeFigureOut">
              <a:rPr lang="en-US" smtClean="0"/>
              <a:t>10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D71C8-F9A3-4146-BBBC-5972CA918D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848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69622" y="1426664"/>
            <a:ext cx="7872153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dirty="0" smtClean="0"/>
              <a:t>SRM assay for validation of protein changes in the pathogenesis of human idiopathic macular hole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1708663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852989" y="501135"/>
            <a:ext cx="21426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DNENVVNEYSSELEK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651503" y="501135"/>
            <a:ext cx="17882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EDGGGWWYNR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1158" y="587834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96297" y="587834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65136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392689" y="501135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9279" y="604459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394958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294244" y="666783"/>
            <a:ext cx="27914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EGFGHLSPTGTTEFWLGNEK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2607944" y="666783"/>
            <a:ext cx="17713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YLQEIYNSNNQK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7998" y="736857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4298" y="736857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111233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09732" y="627587"/>
            <a:ext cx="18861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IHLISTQSAIPYALR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087158" y="627587"/>
            <a:ext cx="24723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ASTPNGYDNGIIWATWK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8210" y="690562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2843" y="690562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038339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18122" y="467884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1676" y="571208"/>
            <a:ext cx="4709491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519204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352479" y="592574"/>
            <a:ext cx="20329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LTFYGN[115]WSEK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7198762" y="592574"/>
            <a:ext cx="16955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VTLSAAPPSYFR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7971" y="654335"/>
            <a:ext cx="4696653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9916" y="654335"/>
            <a:ext cx="4702451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0322317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492443" y="442945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8197995" y="442945"/>
            <a:ext cx="15640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GVAEDIAHILK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8436" y="524306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2908" y="524306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8532814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371491" y="573577"/>
            <a:ext cx="1995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LVADNYASAELGAK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7147449" y="573577"/>
            <a:ext cx="2152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VTEVWTLPQVAGQR</a:t>
            </a:r>
            <a:endParaRPr lang="en-US" dirty="0"/>
          </a:p>
        </p:txBody>
      </p:sp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275" y="657918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7781" y="657918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263265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405663" y="656703"/>
            <a:ext cx="17436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EVLPGQLGYLR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225629" y="656703"/>
            <a:ext cx="17963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HEVLEGNVGYLR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2778" y="716107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2596" y="716107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410327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492441" y="559323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9156" y="641293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86784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19223" y="623455"/>
            <a:ext cx="78007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/>
              <a:t>Correlation of representative 13 differential proteins</a:t>
            </a:r>
            <a:endParaRPr lang="en-US" sz="28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9205" y="1732455"/>
            <a:ext cx="10439925" cy="47212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76381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09157" y="675702"/>
            <a:ext cx="16374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FNVYC[160]FR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224512" y="675702"/>
            <a:ext cx="19824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LFLFPNQTGFPNK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3148" y="742862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2595" y="742862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023959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451578" y="559323"/>
            <a:ext cx="25330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GAQGPPGATGFPGAAGR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7137878" y="559323"/>
            <a:ext cx="28170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GPPGPVGPPGLTGPAGEPGR</a:t>
            </a:r>
            <a:endParaRPr lang="en-US" dirty="0"/>
          </a:p>
        </p:txBody>
      </p:sp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1546" y="637710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8024" y="637710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6819847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500755" y="575949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399722" y="575949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2654" y="662646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3541" y="662646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84760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349259" y="534385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7131848" y="534385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589" y="604459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6093" y="604459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9917549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93842" y="679859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3024" y="765983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716390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322402" y="641323"/>
            <a:ext cx="16774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YISPDQLADLYK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509902" y="758829"/>
            <a:ext cx="17432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LMIEMDGTENK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6792" y="825989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1337" y="758829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59881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7593685" y="397798"/>
            <a:ext cx="19173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LSYT(Cam)EGGFR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2567256" y="397798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9796" y="447675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5533" y="447675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780867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53814" y="343192"/>
            <a:ext cx="23622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_(Cam)FEGFGIDGPAIAK</a:t>
            </a:r>
          </a:p>
        </p:txBody>
      </p:sp>
      <p:sp>
        <p:nvSpPr>
          <p:cNvPr id="5" name="Rectangle 4"/>
          <p:cNvSpPr/>
          <p:nvPr/>
        </p:nvSpPr>
        <p:spPr>
          <a:xfrm>
            <a:off x="7703840" y="343192"/>
            <a:ext cx="28193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_WSSPPQ(Cam)EGLP(Cam)K</a:t>
            </a:r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7098" y="423341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54487" y="423341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782129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8258889" y="542698"/>
            <a:ext cx="18755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DMYSFLEDMGLK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074331" y="542698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1830" y="616352"/>
            <a:ext cx="4669632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6129" y="616352"/>
            <a:ext cx="4669631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334780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702325" y="476196"/>
            <a:ext cx="1632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LPPNVVEESAR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866943" y="476196"/>
            <a:ext cx="25753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LHTEAQIQEEGTVVELTGR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242" y="564053"/>
            <a:ext cx="4669632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2821" y="564053"/>
            <a:ext cx="4669632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174275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76064" y="492821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5905" y="571208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694436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816966" y="559324"/>
            <a:ext cx="19271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GLIDEVNQDFTNR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3068254" y="559324"/>
            <a:ext cx="15706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GSESGIFTNTK</a:t>
            </a:r>
            <a:endParaRPr lang="en-US" dirty="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6423" y="624667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2552" y="624667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874435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852660" y="450653"/>
            <a:ext cx="7512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_Total</a:t>
            </a:r>
            <a:endParaRPr lang="en-US" dirty="0"/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6479" y="560504"/>
            <a:ext cx="4686300" cy="592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96897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</TotalTime>
  <Words>101</Words>
  <Application>Microsoft Office PowerPoint</Application>
  <PresentationFormat>Widescreen</PresentationFormat>
  <Paragraphs>42</Paragraphs>
  <Slides>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2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ngbo Zhang</dc:creator>
  <cp:lastModifiedBy>User</cp:lastModifiedBy>
  <cp:revision>27</cp:revision>
  <dcterms:created xsi:type="dcterms:W3CDTF">2017-10-02T16:52:36Z</dcterms:created>
  <dcterms:modified xsi:type="dcterms:W3CDTF">2017-10-15T17:18:01Z</dcterms:modified>
</cp:coreProperties>
</file>